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4538325" cy="1270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03" userDrawn="1">
          <p15:clr>
            <a:srgbClr val="A4A3A4"/>
          </p15:clr>
        </p15:guide>
        <p15:guide id="2" pos="45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  <a:srgbClr val="FF3399"/>
    <a:srgbClr val="669900"/>
    <a:srgbClr val="00FF00"/>
    <a:srgbClr val="FF0066"/>
    <a:srgbClr val="66FF99"/>
    <a:srgbClr val="66FFFF"/>
    <a:srgbClr val="FED9CE"/>
    <a:srgbClr val="EC90F8"/>
    <a:srgbClr val="22D82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45" d="100"/>
          <a:sy n="45" d="100"/>
        </p:scale>
        <p:origin x="1718" y="53"/>
      </p:cViewPr>
      <p:guideLst>
        <p:guide orient="horz" pos="4003"/>
        <p:guide pos="45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0375" y="2080009"/>
            <a:ext cx="12357576" cy="4424798"/>
          </a:xfrm>
        </p:spPr>
        <p:txBody>
          <a:bodyPr anchor="b"/>
          <a:lstStyle>
            <a:lvl1pPr algn="ctr">
              <a:defRPr sz="95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17291" y="6675443"/>
            <a:ext cx="10903744" cy="3068526"/>
          </a:xfrm>
        </p:spPr>
        <p:txBody>
          <a:bodyPr/>
          <a:lstStyle>
            <a:lvl1pPr marL="0" indent="0" algn="ctr">
              <a:buNone/>
              <a:defRPr sz="3816"/>
            </a:lvl1pPr>
            <a:lvl2pPr marL="726902" indent="0" algn="ctr">
              <a:buNone/>
              <a:defRPr sz="3180"/>
            </a:lvl2pPr>
            <a:lvl3pPr marL="1453805" indent="0" algn="ctr">
              <a:buNone/>
              <a:defRPr sz="2862"/>
            </a:lvl3pPr>
            <a:lvl4pPr marL="2180707" indent="0" algn="ctr">
              <a:buNone/>
              <a:defRPr sz="2544"/>
            </a:lvl4pPr>
            <a:lvl5pPr marL="2907609" indent="0" algn="ctr">
              <a:buNone/>
              <a:defRPr sz="2544"/>
            </a:lvl5pPr>
            <a:lvl6pPr marL="3634511" indent="0" algn="ctr">
              <a:buNone/>
              <a:defRPr sz="2544"/>
            </a:lvl6pPr>
            <a:lvl7pPr marL="4361414" indent="0" algn="ctr">
              <a:buNone/>
              <a:defRPr sz="2544"/>
            </a:lvl7pPr>
            <a:lvl8pPr marL="5088316" indent="0" algn="ctr">
              <a:buNone/>
              <a:defRPr sz="2544"/>
            </a:lvl8pPr>
            <a:lvl9pPr marL="5815218" indent="0" algn="ctr">
              <a:buNone/>
              <a:defRPr sz="25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684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083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03990" y="676665"/>
            <a:ext cx="3134826" cy="107707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9511" y="676665"/>
            <a:ext cx="9222750" cy="1077073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8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443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939" y="3168559"/>
            <a:ext cx="12539305" cy="5286808"/>
          </a:xfrm>
        </p:spPr>
        <p:txBody>
          <a:bodyPr anchor="b"/>
          <a:lstStyle>
            <a:lvl1pPr>
              <a:defRPr sz="95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939" y="8505382"/>
            <a:ext cx="12539305" cy="2780208"/>
          </a:xfrm>
        </p:spPr>
        <p:txBody>
          <a:bodyPr/>
          <a:lstStyle>
            <a:lvl1pPr marL="0" indent="0">
              <a:buNone/>
              <a:defRPr sz="3816">
                <a:solidFill>
                  <a:schemeClr val="tx1"/>
                </a:solidFill>
              </a:defRPr>
            </a:lvl1pPr>
            <a:lvl2pPr marL="726902" indent="0">
              <a:buNone/>
              <a:defRPr sz="3180">
                <a:solidFill>
                  <a:schemeClr val="tx1">
                    <a:tint val="75000"/>
                  </a:schemeClr>
                </a:solidFill>
              </a:defRPr>
            </a:lvl2pPr>
            <a:lvl3pPr marL="1453805" indent="0">
              <a:buNone/>
              <a:defRPr sz="2862">
                <a:solidFill>
                  <a:schemeClr val="tx1">
                    <a:tint val="75000"/>
                  </a:schemeClr>
                </a:solidFill>
              </a:defRPr>
            </a:lvl3pPr>
            <a:lvl4pPr marL="2180707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4pPr>
            <a:lvl5pPr marL="2907609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5pPr>
            <a:lvl6pPr marL="3634511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6pPr>
            <a:lvl7pPr marL="4361414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7pPr>
            <a:lvl8pPr marL="5088316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8pPr>
            <a:lvl9pPr marL="5815218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003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9510" y="3383323"/>
            <a:ext cx="6178788" cy="806407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60027" y="3383323"/>
            <a:ext cx="6178788" cy="806407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510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1404" y="676667"/>
            <a:ext cx="12539305" cy="245658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1405" y="3115600"/>
            <a:ext cx="6150392" cy="1526907"/>
          </a:xfrm>
        </p:spPr>
        <p:txBody>
          <a:bodyPr anchor="b"/>
          <a:lstStyle>
            <a:lvl1pPr marL="0" indent="0">
              <a:buNone/>
              <a:defRPr sz="3816" b="1"/>
            </a:lvl1pPr>
            <a:lvl2pPr marL="726902" indent="0">
              <a:buNone/>
              <a:defRPr sz="3180" b="1"/>
            </a:lvl2pPr>
            <a:lvl3pPr marL="1453805" indent="0">
              <a:buNone/>
              <a:defRPr sz="2862" b="1"/>
            </a:lvl3pPr>
            <a:lvl4pPr marL="2180707" indent="0">
              <a:buNone/>
              <a:defRPr sz="2544" b="1"/>
            </a:lvl4pPr>
            <a:lvl5pPr marL="2907609" indent="0">
              <a:buNone/>
              <a:defRPr sz="2544" b="1"/>
            </a:lvl5pPr>
            <a:lvl6pPr marL="3634511" indent="0">
              <a:buNone/>
              <a:defRPr sz="2544" b="1"/>
            </a:lvl6pPr>
            <a:lvl7pPr marL="4361414" indent="0">
              <a:buNone/>
              <a:defRPr sz="2544" b="1"/>
            </a:lvl7pPr>
            <a:lvl8pPr marL="5088316" indent="0">
              <a:buNone/>
              <a:defRPr sz="2544" b="1"/>
            </a:lvl8pPr>
            <a:lvl9pPr marL="5815218" indent="0">
              <a:buNone/>
              <a:defRPr sz="25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1405" y="4642507"/>
            <a:ext cx="6150392" cy="68284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360028" y="3115600"/>
            <a:ext cx="6180682" cy="1526907"/>
          </a:xfrm>
        </p:spPr>
        <p:txBody>
          <a:bodyPr anchor="b"/>
          <a:lstStyle>
            <a:lvl1pPr marL="0" indent="0">
              <a:buNone/>
              <a:defRPr sz="3816" b="1"/>
            </a:lvl1pPr>
            <a:lvl2pPr marL="726902" indent="0">
              <a:buNone/>
              <a:defRPr sz="3180" b="1"/>
            </a:lvl2pPr>
            <a:lvl3pPr marL="1453805" indent="0">
              <a:buNone/>
              <a:defRPr sz="2862" b="1"/>
            </a:lvl3pPr>
            <a:lvl4pPr marL="2180707" indent="0">
              <a:buNone/>
              <a:defRPr sz="2544" b="1"/>
            </a:lvl4pPr>
            <a:lvl5pPr marL="2907609" indent="0">
              <a:buNone/>
              <a:defRPr sz="2544" b="1"/>
            </a:lvl5pPr>
            <a:lvl6pPr marL="3634511" indent="0">
              <a:buNone/>
              <a:defRPr sz="2544" b="1"/>
            </a:lvl6pPr>
            <a:lvl7pPr marL="4361414" indent="0">
              <a:buNone/>
              <a:defRPr sz="2544" b="1"/>
            </a:lvl7pPr>
            <a:lvl8pPr marL="5088316" indent="0">
              <a:buNone/>
              <a:defRPr sz="2544" b="1"/>
            </a:lvl8pPr>
            <a:lvl9pPr marL="5815218" indent="0">
              <a:buNone/>
              <a:defRPr sz="25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360028" y="4642507"/>
            <a:ext cx="6180682" cy="68284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740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265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909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1404" y="847302"/>
            <a:ext cx="4688988" cy="2965556"/>
          </a:xfrm>
        </p:spPr>
        <p:txBody>
          <a:bodyPr anchor="b"/>
          <a:lstStyle>
            <a:lvl1pPr>
              <a:defRPr sz="50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80682" y="1829939"/>
            <a:ext cx="7360027" cy="9032000"/>
          </a:xfrm>
        </p:spPr>
        <p:txBody>
          <a:bodyPr/>
          <a:lstStyle>
            <a:lvl1pPr>
              <a:defRPr sz="5088"/>
            </a:lvl1pPr>
            <a:lvl2pPr>
              <a:defRPr sz="4452"/>
            </a:lvl2pPr>
            <a:lvl3pPr>
              <a:defRPr sz="3816"/>
            </a:lvl3pPr>
            <a:lvl4pPr>
              <a:defRPr sz="3180"/>
            </a:lvl4pPr>
            <a:lvl5pPr>
              <a:defRPr sz="3180"/>
            </a:lvl5pPr>
            <a:lvl6pPr>
              <a:defRPr sz="3180"/>
            </a:lvl6pPr>
            <a:lvl7pPr>
              <a:defRPr sz="3180"/>
            </a:lvl7pPr>
            <a:lvl8pPr>
              <a:defRPr sz="3180"/>
            </a:lvl8pPr>
            <a:lvl9pPr>
              <a:defRPr sz="318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1404" y="3812858"/>
            <a:ext cx="4688988" cy="7063790"/>
          </a:xfrm>
        </p:spPr>
        <p:txBody>
          <a:bodyPr/>
          <a:lstStyle>
            <a:lvl1pPr marL="0" indent="0">
              <a:buNone/>
              <a:defRPr sz="2544"/>
            </a:lvl1pPr>
            <a:lvl2pPr marL="726902" indent="0">
              <a:buNone/>
              <a:defRPr sz="2226"/>
            </a:lvl2pPr>
            <a:lvl3pPr marL="1453805" indent="0">
              <a:buNone/>
              <a:defRPr sz="1908"/>
            </a:lvl3pPr>
            <a:lvl4pPr marL="2180707" indent="0">
              <a:buNone/>
              <a:defRPr sz="1590"/>
            </a:lvl4pPr>
            <a:lvl5pPr marL="2907609" indent="0">
              <a:buNone/>
              <a:defRPr sz="1590"/>
            </a:lvl5pPr>
            <a:lvl6pPr marL="3634511" indent="0">
              <a:buNone/>
              <a:defRPr sz="1590"/>
            </a:lvl6pPr>
            <a:lvl7pPr marL="4361414" indent="0">
              <a:buNone/>
              <a:defRPr sz="1590"/>
            </a:lvl7pPr>
            <a:lvl8pPr marL="5088316" indent="0">
              <a:buNone/>
              <a:defRPr sz="1590"/>
            </a:lvl8pPr>
            <a:lvl9pPr marL="5815218" indent="0">
              <a:buNone/>
              <a:defRPr sz="159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516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1404" y="847302"/>
            <a:ext cx="4688988" cy="2965556"/>
          </a:xfrm>
        </p:spPr>
        <p:txBody>
          <a:bodyPr anchor="b"/>
          <a:lstStyle>
            <a:lvl1pPr>
              <a:defRPr sz="50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80682" y="1829939"/>
            <a:ext cx="7360027" cy="9032000"/>
          </a:xfrm>
        </p:spPr>
        <p:txBody>
          <a:bodyPr anchor="t"/>
          <a:lstStyle>
            <a:lvl1pPr marL="0" indent="0">
              <a:buNone/>
              <a:defRPr sz="5088"/>
            </a:lvl1pPr>
            <a:lvl2pPr marL="726902" indent="0">
              <a:buNone/>
              <a:defRPr sz="4452"/>
            </a:lvl2pPr>
            <a:lvl3pPr marL="1453805" indent="0">
              <a:buNone/>
              <a:defRPr sz="3816"/>
            </a:lvl3pPr>
            <a:lvl4pPr marL="2180707" indent="0">
              <a:buNone/>
              <a:defRPr sz="3180"/>
            </a:lvl4pPr>
            <a:lvl5pPr marL="2907609" indent="0">
              <a:buNone/>
              <a:defRPr sz="3180"/>
            </a:lvl5pPr>
            <a:lvl6pPr marL="3634511" indent="0">
              <a:buNone/>
              <a:defRPr sz="3180"/>
            </a:lvl6pPr>
            <a:lvl7pPr marL="4361414" indent="0">
              <a:buNone/>
              <a:defRPr sz="3180"/>
            </a:lvl7pPr>
            <a:lvl8pPr marL="5088316" indent="0">
              <a:buNone/>
              <a:defRPr sz="3180"/>
            </a:lvl8pPr>
            <a:lvl9pPr marL="5815218" indent="0">
              <a:buNone/>
              <a:defRPr sz="318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1404" y="3812858"/>
            <a:ext cx="4688988" cy="7063790"/>
          </a:xfrm>
        </p:spPr>
        <p:txBody>
          <a:bodyPr/>
          <a:lstStyle>
            <a:lvl1pPr marL="0" indent="0">
              <a:buNone/>
              <a:defRPr sz="2544"/>
            </a:lvl1pPr>
            <a:lvl2pPr marL="726902" indent="0">
              <a:buNone/>
              <a:defRPr sz="2226"/>
            </a:lvl2pPr>
            <a:lvl3pPr marL="1453805" indent="0">
              <a:buNone/>
              <a:defRPr sz="1908"/>
            </a:lvl3pPr>
            <a:lvl4pPr marL="2180707" indent="0">
              <a:buNone/>
              <a:defRPr sz="1590"/>
            </a:lvl4pPr>
            <a:lvl5pPr marL="2907609" indent="0">
              <a:buNone/>
              <a:defRPr sz="1590"/>
            </a:lvl5pPr>
            <a:lvl6pPr marL="3634511" indent="0">
              <a:buNone/>
              <a:defRPr sz="1590"/>
            </a:lvl6pPr>
            <a:lvl7pPr marL="4361414" indent="0">
              <a:buNone/>
              <a:defRPr sz="1590"/>
            </a:lvl7pPr>
            <a:lvl8pPr marL="5088316" indent="0">
              <a:buNone/>
              <a:defRPr sz="1590"/>
            </a:lvl8pPr>
            <a:lvl9pPr marL="5815218" indent="0">
              <a:buNone/>
              <a:defRPr sz="159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194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9510" y="676667"/>
            <a:ext cx="12539305" cy="24565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9510" y="3383323"/>
            <a:ext cx="12539305" cy="80640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9510" y="11779849"/>
            <a:ext cx="3271123" cy="676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BBFC4-F7D1-4650-8C32-5BF58EA9E8E8}" type="datetimeFigureOut">
              <a:rPr lang="en-US" smtClean="0"/>
              <a:t>3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15820" y="11779849"/>
            <a:ext cx="4906685" cy="676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267692" y="11779849"/>
            <a:ext cx="3271123" cy="676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E05F3-6A7D-49D1-BA3E-CCF57DC5D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371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53805" rtl="0" eaLnBrk="1" latinLnBrk="0" hangingPunct="1">
        <a:lnSpc>
          <a:spcPct val="90000"/>
        </a:lnSpc>
        <a:spcBef>
          <a:spcPct val="0"/>
        </a:spcBef>
        <a:buNone/>
        <a:defRPr sz="69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3451" indent="-363451" algn="l" defTabSz="1453805" rtl="0" eaLnBrk="1" latinLnBrk="0" hangingPunct="1">
        <a:lnSpc>
          <a:spcPct val="90000"/>
        </a:lnSpc>
        <a:spcBef>
          <a:spcPts val="1590"/>
        </a:spcBef>
        <a:buFont typeface="Arial" panose="020B0604020202020204" pitchFamily="34" charset="0"/>
        <a:buChar char="•"/>
        <a:defRPr sz="4452" kern="1200">
          <a:solidFill>
            <a:schemeClr val="tx1"/>
          </a:solidFill>
          <a:latin typeface="+mn-lt"/>
          <a:ea typeface="+mn-ea"/>
          <a:cs typeface="+mn-cs"/>
        </a:defRPr>
      </a:lvl1pPr>
      <a:lvl2pPr marL="1090353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3816" kern="1200">
          <a:solidFill>
            <a:schemeClr val="tx1"/>
          </a:solidFill>
          <a:latin typeface="+mn-lt"/>
          <a:ea typeface="+mn-ea"/>
          <a:cs typeface="+mn-cs"/>
        </a:defRPr>
      </a:lvl2pPr>
      <a:lvl3pPr marL="1817256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3180" kern="1200">
          <a:solidFill>
            <a:schemeClr val="tx1"/>
          </a:solidFill>
          <a:latin typeface="+mn-lt"/>
          <a:ea typeface="+mn-ea"/>
          <a:cs typeface="+mn-cs"/>
        </a:defRPr>
      </a:lvl3pPr>
      <a:lvl4pPr marL="2544158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2862" kern="1200">
          <a:solidFill>
            <a:schemeClr val="tx1"/>
          </a:solidFill>
          <a:latin typeface="+mn-lt"/>
          <a:ea typeface="+mn-ea"/>
          <a:cs typeface="+mn-cs"/>
        </a:defRPr>
      </a:lvl4pPr>
      <a:lvl5pPr marL="3271060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2862" kern="1200">
          <a:solidFill>
            <a:schemeClr val="tx1"/>
          </a:solidFill>
          <a:latin typeface="+mn-lt"/>
          <a:ea typeface="+mn-ea"/>
          <a:cs typeface="+mn-cs"/>
        </a:defRPr>
      </a:lvl5pPr>
      <a:lvl6pPr marL="3997963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2862" kern="1200">
          <a:solidFill>
            <a:schemeClr val="tx1"/>
          </a:solidFill>
          <a:latin typeface="+mn-lt"/>
          <a:ea typeface="+mn-ea"/>
          <a:cs typeface="+mn-cs"/>
        </a:defRPr>
      </a:lvl6pPr>
      <a:lvl7pPr marL="4724865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2862" kern="1200">
          <a:solidFill>
            <a:schemeClr val="tx1"/>
          </a:solidFill>
          <a:latin typeface="+mn-lt"/>
          <a:ea typeface="+mn-ea"/>
          <a:cs typeface="+mn-cs"/>
        </a:defRPr>
      </a:lvl7pPr>
      <a:lvl8pPr marL="5451767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2862" kern="1200">
          <a:solidFill>
            <a:schemeClr val="tx1"/>
          </a:solidFill>
          <a:latin typeface="+mn-lt"/>
          <a:ea typeface="+mn-ea"/>
          <a:cs typeface="+mn-cs"/>
        </a:defRPr>
      </a:lvl8pPr>
      <a:lvl9pPr marL="6178669" indent="-363451" algn="l" defTabSz="1453805" rtl="0" eaLnBrk="1" latinLnBrk="0" hangingPunct="1">
        <a:lnSpc>
          <a:spcPct val="90000"/>
        </a:lnSpc>
        <a:spcBef>
          <a:spcPts val="795"/>
        </a:spcBef>
        <a:buFont typeface="Arial" panose="020B0604020202020204" pitchFamily="34" charset="0"/>
        <a:buChar char="•"/>
        <a:defRPr sz="28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1pPr>
      <a:lvl2pPr marL="726902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2pPr>
      <a:lvl3pPr marL="1453805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3pPr>
      <a:lvl4pPr marL="2180707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4pPr>
      <a:lvl5pPr marL="2907609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5pPr>
      <a:lvl6pPr marL="3634511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6pPr>
      <a:lvl7pPr marL="4361414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7pPr>
      <a:lvl8pPr marL="5088316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8pPr>
      <a:lvl9pPr marL="5815218" algn="l" defTabSz="1453805" rtl="0" eaLnBrk="1" latinLnBrk="0" hangingPunct="1">
        <a:defRPr sz="28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6" name="Group 95">
            <a:extLst>
              <a:ext uri="{FF2B5EF4-FFF2-40B4-BE49-F238E27FC236}">
                <a16:creationId xmlns:a16="http://schemas.microsoft.com/office/drawing/2014/main" id="{49E79282-2782-41FB-AB1F-BB756E61ADBA}"/>
              </a:ext>
            </a:extLst>
          </p:cNvPr>
          <p:cNvGrpSpPr/>
          <p:nvPr/>
        </p:nvGrpSpPr>
        <p:grpSpPr>
          <a:xfrm>
            <a:off x="-114294" y="556055"/>
            <a:ext cx="14308837" cy="10096075"/>
            <a:chOff x="83820" y="1007921"/>
            <a:chExt cx="14308837" cy="10096075"/>
          </a:xfrm>
        </p:grpSpPr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BBFBAFEA-F7D2-4C4E-8E0A-62A82CABE189}"/>
                </a:ext>
              </a:extLst>
            </p:cNvPr>
            <p:cNvSpPr/>
            <p:nvPr/>
          </p:nvSpPr>
          <p:spPr>
            <a:xfrm>
              <a:off x="10826496" y="2172870"/>
              <a:ext cx="3061752" cy="1887066"/>
            </a:xfrm>
            <a:prstGeom prst="ellipse">
              <a:avLst/>
            </a:prstGeom>
            <a:solidFill>
              <a:schemeClr val="accent4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93" name="Flowchart: Punched Tape 92">
              <a:extLst>
                <a:ext uri="{FF2B5EF4-FFF2-40B4-BE49-F238E27FC236}">
                  <a16:creationId xmlns:a16="http://schemas.microsoft.com/office/drawing/2014/main" id="{2A8724EA-4D19-4B7B-B283-CFE8C6012079}"/>
                </a:ext>
              </a:extLst>
            </p:cNvPr>
            <p:cNvSpPr/>
            <p:nvPr/>
          </p:nvSpPr>
          <p:spPr>
            <a:xfrm>
              <a:off x="7231063" y="8393663"/>
              <a:ext cx="3547872" cy="2637181"/>
            </a:xfrm>
            <a:prstGeom prst="flowChartPunchedTape">
              <a:avLst/>
            </a:prstGeom>
            <a:solidFill>
              <a:srgbClr val="66FF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3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structure and domain analysis</a:t>
              </a:r>
            </a:p>
          </p:txBody>
        </p:sp>
        <p:sp>
          <p:nvSpPr>
            <p:cNvPr id="88" name="Flowchart: Punched Tape 87">
              <a:extLst>
                <a:ext uri="{FF2B5EF4-FFF2-40B4-BE49-F238E27FC236}">
                  <a16:creationId xmlns:a16="http://schemas.microsoft.com/office/drawing/2014/main" id="{A642B6CA-9D9C-4F64-A591-424DA7E01673}"/>
                </a:ext>
              </a:extLst>
            </p:cNvPr>
            <p:cNvSpPr/>
            <p:nvPr/>
          </p:nvSpPr>
          <p:spPr>
            <a:xfrm>
              <a:off x="219456" y="8393663"/>
              <a:ext cx="3244279" cy="2637181"/>
            </a:xfrm>
            <a:prstGeom prst="flowChartPunchedTape">
              <a:avLst/>
            </a:prstGeom>
            <a:solidFill>
              <a:srgbClr val="6699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" name="Rectangle: Rounded Corners 3">
              <a:extLst>
                <a:ext uri="{FF2B5EF4-FFF2-40B4-BE49-F238E27FC236}">
                  <a16:creationId xmlns:a16="http://schemas.microsoft.com/office/drawing/2014/main" id="{DC166635-CA0D-4FF6-A854-942D00832782}"/>
                </a:ext>
              </a:extLst>
            </p:cNvPr>
            <p:cNvSpPr/>
            <p:nvPr/>
          </p:nvSpPr>
          <p:spPr>
            <a:xfrm>
              <a:off x="6609537" y="2627185"/>
              <a:ext cx="2713220" cy="854439"/>
            </a:xfrm>
            <a:prstGeom prst="roundRect">
              <a:avLst/>
            </a:prstGeom>
            <a:solidFill>
              <a:srgbClr val="EC90F8"/>
            </a:solidFill>
            <a:ln w="28575">
              <a:solidFill>
                <a:srgbClr val="18479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6" name="Arrow: Right 5">
              <a:extLst>
                <a:ext uri="{FF2B5EF4-FFF2-40B4-BE49-F238E27FC236}">
                  <a16:creationId xmlns:a16="http://schemas.microsoft.com/office/drawing/2014/main" id="{34307A26-12E0-464A-A0AD-42BCA9C804C8}"/>
                </a:ext>
              </a:extLst>
            </p:cNvPr>
            <p:cNvSpPr/>
            <p:nvPr/>
          </p:nvSpPr>
          <p:spPr>
            <a:xfrm rot="10800000">
              <a:off x="9377878" y="2660437"/>
              <a:ext cx="1394085" cy="734517"/>
            </a:xfrm>
            <a:prstGeom prst="rightArrow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8" name="Arrow: Right 7">
              <a:extLst>
                <a:ext uri="{FF2B5EF4-FFF2-40B4-BE49-F238E27FC236}">
                  <a16:creationId xmlns:a16="http://schemas.microsoft.com/office/drawing/2014/main" id="{042C55E9-9F61-4EDC-9817-87A376D35F0D}"/>
                </a:ext>
              </a:extLst>
            </p:cNvPr>
            <p:cNvSpPr/>
            <p:nvPr/>
          </p:nvSpPr>
          <p:spPr>
            <a:xfrm rot="5400000">
              <a:off x="7783824" y="1983672"/>
              <a:ext cx="524655" cy="494676"/>
            </a:xfrm>
            <a:prstGeom prst="rightArrow">
              <a:avLst>
                <a:gd name="adj1" fmla="val 50002"/>
                <a:gd name="adj2" fmla="val 50000"/>
              </a:avLst>
            </a:prstGeom>
            <a:solidFill>
              <a:schemeClr val="accent2">
                <a:lumMod val="75000"/>
              </a:schemeClr>
            </a:solidFill>
            <a:ln>
              <a:solidFill>
                <a:srgbClr val="18479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6" name="Arrow: Right 15">
              <a:extLst>
                <a:ext uri="{FF2B5EF4-FFF2-40B4-BE49-F238E27FC236}">
                  <a16:creationId xmlns:a16="http://schemas.microsoft.com/office/drawing/2014/main" id="{F7AFE5F5-9989-4BCD-B7F0-195A2FD1C8BA}"/>
                </a:ext>
              </a:extLst>
            </p:cNvPr>
            <p:cNvSpPr/>
            <p:nvPr/>
          </p:nvSpPr>
          <p:spPr>
            <a:xfrm rot="5400000">
              <a:off x="7768834" y="3578735"/>
              <a:ext cx="524655" cy="494676"/>
            </a:xfrm>
            <a:prstGeom prst="rightArrow">
              <a:avLst>
                <a:gd name="adj1" fmla="val 50001"/>
                <a:gd name="adj2" fmla="val 50000"/>
              </a:avLst>
            </a:prstGeom>
            <a:solidFill>
              <a:schemeClr val="accent2">
                <a:lumMod val="75000"/>
              </a:schemeClr>
            </a:solidFill>
            <a:ln>
              <a:solidFill>
                <a:srgbClr val="18479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7" name="Arrow: Right 16">
              <a:extLst>
                <a:ext uri="{FF2B5EF4-FFF2-40B4-BE49-F238E27FC236}">
                  <a16:creationId xmlns:a16="http://schemas.microsoft.com/office/drawing/2014/main" id="{1BD8AAD1-F6EF-4870-AE01-B6D3E15A549C}"/>
                </a:ext>
              </a:extLst>
            </p:cNvPr>
            <p:cNvSpPr/>
            <p:nvPr/>
          </p:nvSpPr>
          <p:spPr>
            <a:xfrm rot="5400000">
              <a:off x="7778447" y="5085740"/>
              <a:ext cx="524655" cy="494676"/>
            </a:xfrm>
            <a:prstGeom prst="rightArrow">
              <a:avLst>
                <a:gd name="adj1" fmla="val 50001"/>
                <a:gd name="adj2" fmla="val 50000"/>
              </a:avLst>
            </a:prstGeom>
            <a:solidFill>
              <a:schemeClr val="accent2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8" name="Rectangle: Rounded Corners 17">
              <a:extLst>
                <a:ext uri="{FF2B5EF4-FFF2-40B4-BE49-F238E27FC236}">
                  <a16:creationId xmlns:a16="http://schemas.microsoft.com/office/drawing/2014/main" id="{13A2CEA9-7D6C-4983-B907-55F3B476A2FD}"/>
                </a:ext>
              </a:extLst>
            </p:cNvPr>
            <p:cNvSpPr/>
            <p:nvPr/>
          </p:nvSpPr>
          <p:spPr>
            <a:xfrm>
              <a:off x="6614588" y="4140866"/>
              <a:ext cx="2713220" cy="854439"/>
            </a:xfrm>
            <a:prstGeom prst="roundRect">
              <a:avLst/>
            </a:prstGeom>
            <a:solidFill>
              <a:srgbClr val="92D050"/>
            </a:solidFill>
            <a:ln w="28575">
              <a:solidFill>
                <a:srgbClr val="18479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9" name="Arrow: Right 18">
              <a:extLst>
                <a:ext uri="{FF2B5EF4-FFF2-40B4-BE49-F238E27FC236}">
                  <a16:creationId xmlns:a16="http://schemas.microsoft.com/office/drawing/2014/main" id="{F4E8AC0E-5EF0-481C-AB22-F405B133446F}"/>
                </a:ext>
              </a:extLst>
            </p:cNvPr>
            <p:cNvSpPr/>
            <p:nvPr/>
          </p:nvSpPr>
          <p:spPr>
            <a:xfrm rot="5400000">
              <a:off x="7840163" y="6721093"/>
              <a:ext cx="524655" cy="494676"/>
            </a:xfrm>
            <a:prstGeom prst="rightArrow">
              <a:avLst>
                <a:gd name="adj1" fmla="val 50001"/>
                <a:gd name="adj2" fmla="val 50000"/>
              </a:avLst>
            </a:prstGeom>
            <a:solidFill>
              <a:schemeClr val="accent2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22" name="Arrow: Right 21">
              <a:extLst>
                <a:ext uri="{FF2B5EF4-FFF2-40B4-BE49-F238E27FC236}">
                  <a16:creationId xmlns:a16="http://schemas.microsoft.com/office/drawing/2014/main" id="{C3B405CD-005B-40EB-A6CC-8FFE775B9D31}"/>
                </a:ext>
              </a:extLst>
            </p:cNvPr>
            <p:cNvSpPr/>
            <p:nvPr/>
          </p:nvSpPr>
          <p:spPr>
            <a:xfrm>
              <a:off x="5116631" y="2682558"/>
              <a:ext cx="1394085" cy="734517"/>
            </a:xfrm>
            <a:prstGeom prst="rightArrow">
              <a:avLst/>
            </a:prstGeom>
            <a:solidFill>
              <a:srgbClr val="18479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23" name="Rectangle: Rounded Corners 22">
              <a:extLst>
                <a:ext uri="{FF2B5EF4-FFF2-40B4-BE49-F238E27FC236}">
                  <a16:creationId xmlns:a16="http://schemas.microsoft.com/office/drawing/2014/main" id="{0FB38098-A101-4198-BA4F-B30951D12CFE}"/>
                </a:ext>
              </a:extLst>
            </p:cNvPr>
            <p:cNvSpPr/>
            <p:nvPr/>
          </p:nvSpPr>
          <p:spPr>
            <a:xfrm>
              <a:off x="6599598" y="1007921"/>
              <a:ext cx="2873585" cy="894031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28575">
              <a:solidFill>
                <a:schemeClr val="accent6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24" name="Rectangle: Rounded Corners 23">
              <a:extLst>
                <a:ext uri="{FF2B5EF4-FFF2-40B4-BE49-F238E27FC236}">
                  <a16:creationId xmlns:a16="http://schemas.microsoft.com/office/drawing/2014/main" id="{BBFA3F79-F76B-44B0-872F-1D84D88F4311}"/>
                </a:ext>
              </a:extLst>
            </p:cNvPr>
            <p:cNvSpPr/>
            <p:nvPr/>
          </p:nvSpPr>
          <p:spPr>
            <a:xfrm>
              <a:off x="6509657" y="5625541"/>
              <a:ext cx="2908095" cy="1004341"/>
            </a:xfrm>
            <a:prstGeom prst="roundRect">
              <a:avLst/>
            </a:prstGeom>
            <a:solidFill>
              <a:schemeClr val="accent4">
                <a:lumMod val="75000"/>
              </a:schemeClr>
            </a:solidFill>
            <a:ln w="285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E7FAA0CD-A3AC-45BE-A433-22D6A1E5474C}"/>
                </a:ext>
              </a:extLst>
            </p:cNvPr>
            <p:cNvCxnSpPr>
              <a:cxnSpLocks/>
            </p:cNvCxnSpPr>
            <p:nvPr/>
          </p:nvCxnSpPr>
          <p:spPr>
            <a:xfrm>
              <a:off x="1335024" y="7461504"/>
              <a:ext cx="11064240" cy="0"/>
            </a:xfrm>
            <a:prstGeom prst="line">
              <a:avLst/>
            </a:prstGeom>
            <a:ln w="952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50EFF2A7-5EBD-4560-800D-2284732B6A42}"/>
                </a:ext>
              </a:extLst>
            </p:cNvPr>
            <p:cNvCxnSpPr>
              <a:cxnSpLocks/>
            </p:cNvCxnSpPr>
            <p:nvPr/>
          </p:nvCxnSpPr>
          <p:spPr>
            <a:xfrm>
              <a:off x="1371600" y="7424928"/>
              <a:ext cx="0" cy="1316736"/>
            </a:xfrm>
            <a:prstGeom prst="straightConnector1">
              <a:avLst/>
            </a:prstGeom>
            <a:ln w="107950">
              <a:solidFill>
                <a:schemeClr val="accent1">
                  <a:lumMod val="75000"/>
                </a:schemeClr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5ED82C61-4F31-4A0F-867A-257D2A5D1F8B}"/>
                </a:ext>
              </a:extLst>
            </p:cNvPr>
            <p:cNvCxnSpPr>
              <a:cxnSpLocks/>
            </p:cNvCxnSpPr>
            <p:nvPr/>
          </p:nvCxnSpPr>
          <p:spPr>
            <a:xfrm>
              <a:off x="5065776" y="7424928"/>
              <a:ext cx="0" cy="1316736"/>
            </a:xfrm>
            <a:prstGeom prst="straightConnector1">
              <a:avLst/>
            </a:prstGeom>
            <a:ln w="107950">
              <a:solidFill>
                <a:schemeClr val="accent1">
                  <a:lumMod val="75000"/>
                </a:schemeClr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4C5BB994-9CF8-4B1A-8B31-B5CA92F46D57}"/>
                </a:ext>
              </a:extLst>
            </p:cNvPr>
            <p:cNvCxnSpPr>
              <a:cxnSpLocks/>
            </p:cNvCxnSpPr>
            <p:nvPr/>
          </p:nvCxnSpPr>
          <p:spPr>
            <a:xfrm>
              <a:off x="8778240" y="7443216"/>
              <a:ext cx="0" cy="1316736"/>
            </a:xfrm>
            <a:prstGeom prst="straightConnector1">
              <a:avLst/>
            </a:prstGeom>
            <a:ln w="107950">
              <a:solidFill>
                <a:schemeClr val="accent1">
                  <a:lumMod val="75000"/>
                </a:schemeClr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A43BDCB6-9304-4705-9F2D-6F4E0B8FBEEC}"/>
                </a:ext>
              </a:extLst>
            </p:cNvPr>
            <p:cNvCxnSpPr>
              <a:cxnSpLocks/>
            </p:cNvCxnSpPr>
            <p:nvPr/>
          </p:nvCxnSpPr>
          <p:spPr>
            <a:xfrm>
              <a:off x="12344400" y="7424928"/>
              <a:ext cx="0" cy="1335024"/>
            </a:xfrm>
            <a:prstGeom prst="straightConnector1">
              <a:avLst/>
            </a:prstGeom>
            <a:ln w="107950">
              <a:solidFill>
                <a:schemeClr val="accent1">
                  <a:lumMod val="75000"/>
                </a:schemeClr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BB183AB-BAE4-40EB-9FBA-197831FFFC33}"/>
                </a:ext>
              </a:extLst>
            </p:cNvPr>
            <p:cNvSpPr txBox="1"/>
            <p:nvPr/>
          </p:nvSpPr>
          <p:spPr>
            <a:xfrm>
              <a:off x="6457507" y="2837950"/>
              <a:ext cx="31601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le</a:t>
              </a:r>
              <a:r>
                <a:rPr lang="en-US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DPK </a:t>
              </a:r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8B0BB53-1744-434B-929A-0371C4E93079}"/>
                </a:ext>
              </a:extLst>
            </p:cNvPr>
            <p:cNvSpPr txBox="1"/>
            <p:nvPr/>
          </p:nvSpPr>
          <p:spPr>
            <a:xfrm>
              <a:off x="8899450" y="2830861"/>
              <a:ext cx="24760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MM scan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5C101E19-914B-4E23-B71C-D3DEF0663B2F}"/>
                </a:ext>
              </a:extLst>
            </p:cNvPr>
            <p:cNvSpPr txBox="1"/>
            <p:nvPr/>
          </p:nvSpPr>
          <p:spPr>
            <a:xfrm>
              <a:off x="11009376" y="2497129"/>
              <a:ext cx="29077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id="{322049E4-3E67-4186-98F0-ACA99EC66786}"/>
                </a:ext>
              </a:extLst>
            </p:cNvPr>
            <p:cNvSpPr/>
            <p:nvPr/>
          </p:nvSpPr>
          <p:spPr>
            <a:xfrm>
              <a:off x="1956816" y="2209446"/>
              <a:ext cx="3061752" cy="1887066"/>
            </a:xfrm>
            <a:prstGeom prst="ellipse">
              <a:avLst/>
            </a:prstGeom>
            <a:solidFill>
              <a:srgbClr val="22D82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47CD6BF5-7999-481D-B341-92D1C66EFBFD}"/>
                </a:ext>
              </a:extLst>
            </p:cNvPr>
            <p:cNvSpPr txBox="1"/>
            <p:nvPr/>
          </p:nvSpPr>
          <p:spPr>
            <a:xfrm>
              <a:off x="2160962" y="2759046"/>
              <a:ext cx="273401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 sequences from</a:t>
              </a:r>
              <a:r>
                <a:rPr lang="en-IN" sz="2400" dirty="0">
                  <a:solidFill>
                    <a:schemeClr val="bg1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 A. agallocha </a:t>
              </a:r>
              <a:endParaRPr lang="en-US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8ED014B5-8024-478B-82FB-DF6A31E94C3F}"/>
                </a:ext>
              </a:extLst>
            </p:cNvPr>
            <p:cNvSpPr txBox="1"/>
            <p:nvPr/>
          </p:nvSpPr>
          <p:spPr>
            <a:xfrm>
              <a:off x="4511748" y="2834405"/>
              <a:ext cx="24760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lastP</a:t>
              </a:r>
              <a:endParaRPr lang="en-US" sz="2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9899A7E-6BC9-4709-9EDC-3833A6DEDA32}"/>
                </a:ext>
              </a:extLst>
            </p:cNvPr>
            <p:cNvSpPr txBox="1"/>
            <p:nvPr/>
          </p:nvSpPr>
          <p:spPr>
            <a:xfrm>
              <a:off x="6474331" y="4263894"/>
              <a:ext cx="316011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main analysis by SMART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494C651-0B4C-44C1-ADA8-5ABA21DFD71D}"/>
                </a:ext>
              </a:extLst>
            </p:cNvPr>
            <p:cNvSpPr txBox="1"/>
            <p:nvPr/>
          </p:nvSpPr>
          <p:spPr>
            <a:xfrm>
              <a:off x="6413794" y="5805221"/>
              <a:ext cx="31601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utative </a:t>
              </a:r>
              <a:r>
                <a:rPr lang="en-US" sz="2000" b="1" i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aCDPK</a:t>
              </a:r>
              <a:r>
                <a:rPr lang="en-US" sz="2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nd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144F419-EF82-4707-BCCD-103E354415B3}"/>
                </a:ext>
              </a:extLst>
            </p:cNvPr>
            <p:cNvSpPr txBox="1"/>
            <p:nvPr/>
          </p:nvSpPr>
          <p:spPr>
            <a:xfrm>
              <a:off x="83820" y="9165389"/>
              <a:ext cx="3581063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ysiological properties analysis of putative </a:t>
              </a:r>
              <a:r>
                <a:rPr lang="en-US" sz="24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aCDPK</a:t>
              </a:r>
              <a:endParaRPr lang="en-US" sz="24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Flowchart: Punched Tape 90">
              <a:extLst>
                <a:ext uri="{FF2B5EF4-FFF2-40B4-BE49-F238E27FC236}">
                  <a16:creationId xmlns:a16="http://schemas.microsoft.com/office/drawing/2014/main" id="{894B6B32-66C4-4031-8826-C5F0D60232D3}"/>
                </a:ext>
              </a:extLst>
            </p:cNvPr>
            <p:cNvSpPr/>
            <p:nvPr/>
          </p:nvSpPr>
          <p:spPr>
            <a:xfrm>
              <a:off x="3785616" y="8466815"/>
              <a:ext cx="3244279" cy="2637181"/>
            </a:xfrm>
            <a:prstGeom prst="flowChartPunchedTape">
              <a:avLst/>
            </a:prstGeom>
            <a:solidFill>
              <a:srgbClr val="3366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4" name="Flowchart: Punched Tape 93">
              <a:extLst>
                <a:ext uri="{FF2B5EF4-FFF2-40B4-BE49-F238E27FC236}">
                  <a16:creationId xmlns:a16="http://schemas.microsoft.com/office/drawing/2014/main" id="{DAD3E950-3D34-4751-8DF0-8B041EF9212B}"/>
                </a:ext>
              </a:extLst>
            </p:cNvPr>
            <p:cNvSpPr/>
            <p:nvPr/>
          </p:nvSpPr>
          <p:spPr>
            <a:xfrm>
              <a:off x="10972801" y="8338799"/>
              <a:ext cx="3419856" cy="2637181"/>
            </a:xfrm>
            <a:prstGeom prst="flowChartPunchedTape">
              <a:avLst/>
            </a:prstGeom>
            <a:solidFill>
              <a:srgbClr val="66FF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FF81D27B-5823-439B-9F03-A65D5A98C7B9}"/>
                </a:ext>
              </a:extLst>
            </p:cNvPr>
            <p:cNvSpPr txBox="1"/>
            <p:nvPr/>
          </p:nvSpPr>
          <p:spPr>
            <a:xfrm>
              <a:off x="3449570" y="9009330"/>
              <a:ext cx="3781493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B56819BF-8F6A-40D9-8106-207D92EA5D24}"/>
                </a:ext>
              </a:extLst>
            </p:cNvPr>
            <p:cNvSpPr txBox="1"/>
            <p:nvPr/>
          </p:nvSpPr>
          <p:spPr>
            <a:xfrm>
              <a:off x="10770281" y="8895860"/>
              <a:ext cx="3539656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nctional annotation and PPI</a:t>
              </a:r>
            </a:p>
          </p:txBody>
        </p:sp>
      </p:grpSp>
      <p:sp>
        <p:nvSpPr>
          <p:cNvPr id="97" name="TextBox 96">
            <a:extLst>
              <a:ext uri="{FF2B5EF4-FFF2-40B4-BE49-F238E27FC236}">
                <a16:creationId xmlns:a16="http://schemas.microsoft.com/office/drawing/2014/main" id="{97CC1493-973F-40BD-B8CF-C7BBB75CB24B}"/>
              </a:ext>
            </a:extLst>
          </p:cNvPr>
          <p:cNvSpPr txBox="1"/>
          <p:nvPr/>
        </p:nvSpPr>
        <p:spPr>
          <a:xfrm>
            <a:off x="6758907" y="832585"/>
            <a:ext cx="25572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agallocha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793A695-E47C-43BC-AE67-1347EF63904A}"/>
              </a:ext>
            </a:extLst>
          </p:cNvPr>
          <p:cNvSpPr/>
          <p:nvPr/>
        </p:nvSpPr>
        <p:spPr>
          <a:xfrm>
            <a:off x="3657605" y="8798997"/>
            <a:ext cx="3319487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BE31FAA-A31B-4CE8-83E6-F95F17261141}"/>
              </a:ext>
            </a:extLst>
          </p:cNvPr>
          <p:cNvSpPr/>
          <p:nvPr/>
        </p:nvSpPr>
        <p:spPr>
          <a:xfrm>
            <a:off x="10752143" y="2145398"/>
            <a:ext cx="7267575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sz="20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Protein kinase domain </a:t>
            </a:r>
          </a:p>
          <a:p>
            <a:r>
              <a:rPr lang="en-GB" sz="20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(PF00069), </a:t>
            </a:r>
          </a:p>
          <a:p>
            <a:r>
              <a:rPr lang="en-GB" sz="2000" dirty="0">
                <a:solidFill>
                  <a:schemeClr val="bg1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EF hand domain (PF13499) </a:t>
            </a:r>
            <a:endParaRPr lang="en-US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8213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1</TotalTime>
  <Words>53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leda</dc:creator>
  <cp:lastModifiedBy>Khaleda</cp:lastModifiedBy>
  <cp:revision>32</cp:revision>
  <dcterms:created xsi:type="dcterms:W3CDTF">2023-02-27T08:01:11Z</dcterms:created>
  <dcterms:modified xsi:type="dcterms:W3CDTF">2025-03-21T02:06:11Z</dcterms:modified>
</cp:coreProperties>
</file>